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C294D-701E-4A56-A1DF-5A536B8B72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EA60DD-B2C0-47A9-A88E-9F2FAC9604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7FC686-BE1B-4FE2-80F5-94F33A9D5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CC56E-37D2-4F65-B87C-155D2DDD7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5E505C-87CE-4B4E-A939-1DE54422B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95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5F082-ED2C-48E6-85BB-D2BB7C797E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B62B81-D435-4A90-B1F3-4A9B8D7EBF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93137C-1297-4F33-B029-5BC60CFDF5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35995-95E7-48C0-B63A-3727BD13C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A2AA8-2C07-4638-BF4B-B7C7EC0C8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796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32D0D2-F533-4417-936E-7FB3EB5985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9F2C11-D987-4725-8F9E-EFB62C466E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5EA6FB-2BA3-4349-9C60-779368D693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5B187B-2788-4950-A49C-7FB1DADE4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5BD433-C202-47EB-B772-F1EA9888E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59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DBA63-02C4-40F1-A54D-BF9354EDB3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D09A15-4D05-42A8-A13C-AA9B27AD3E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1B173-E535-4A93-9807-0978952F6C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990D7A-E869-44DA-8727-F6B27B55B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A27BD6-778E-4801-A2EE-0B1F17A85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55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F4951-3821-412C-B92E-5E385E30D4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DD4FC6-21A4-44AA-BD94-DB71796768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323444-C22A-4940-A516-A647EA067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9D2869-94C7-4FBA-BF23-194350D7A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C2A4-6947-4E08-A84E-386DAEBB3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822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79048-E454-40EA-912A-DB52A3051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A1C4A-6619-4ABF-A8DE-A16DB41DD3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ED3302-6AA1-425C-9F65-200CE17351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E13F7-B8DB-45D6-82B0-0AD7D2E2B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0AFA9D-641E-445F-B3F3-C41D98118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29315F-AF16-40BA-80CD-0CD04E6B1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7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87A3C8-7547-4E34-A727-D3E9A3344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EFE30A-4076-4004-B27E-83B873357A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4F7588-9BC1-4DCD-8D1D-BB0635E51E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074C51-D5BD-45E4-A5EC-EB65FA3D03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725683-A132-45AB-A7A2-3C912A9E14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60A8E44-32AB-4C54-BC7A-63CA6E4F5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3D13CA-68E3-4BEE-8C61-203999208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CCA7A6-25CD-44DC-BF74-7A42A0AA7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939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5BFE9-3EDB-4CBD-BE5A-925BAD3833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A072C4-4259-491A-8E7C-D53C64503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5698525-B831-4D12-B2F0-5E97430DD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7C048C-2926-462A-A982-C46F25C80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668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0EF9EAB-7FC6-4CE9-8403-368805157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EA67D6-60FC-4CDD-9A98-68F3B4682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0CFC18-57A4-4563-AE90-A27D78DD4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08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9C1DDE-4542-4CF3-B68A-F333B8E72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68580D-0A74-4228-9C1E-CF01A0EB84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A7527A-48DE-45DC-87EF-04033D8F10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2164A7-6B1F-4405-851A-395C2AFA8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EFE0FE-80A4-407A-B879-8C8170A7F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89D10D-8FD2-4900-9940-C4F46604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527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E98B0-37F5-4207-B716-56D1DE76A3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CC58F6E-5F5F-4DD5-8652-6172A52938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92102F-EC23-4CCD-B8D0-82106DACC7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59EC04-35F7-4A55-B5F7-E286317C7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111886-49E3-4F3D-8411-F5D6FD2DC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B5E544-4456-44D5-A88B-B67743A64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231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E6FA4FA-9088-4CF0-BE50-23B6E8CEA1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4CD7B2-1C2B-41F9-AC1F-88D629D63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DFA964-94B3-4E30-8057-D9E100D1EC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7F4F2-EEDB-4B03-AA16-2865CD827439}" type="datetimeFigureOut">
              <a:rPr lang="en-US" smtClean="0"/>
              <a:t>10/2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DB538-02FB-4AF3-B386-AEBFA9CAA5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28FFEC-D23F-46C7-983C-66B67B4B29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2550E-9CC3-40C3-ABAB-49B7B29535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757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5FE683-611E-43AF-BDA5-05421E5B9C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19676"/>
            <a:ext cx="10515600" cy="5754619"/>
          </a:xfrm>
        </p:spPr>
        <p:txBody>
          <a:bodyPr>
            <a:norm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Title: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ffects of Mechanical Abrasion Challenge on Sound and Demineralized Dentin Surfaces treated with SDF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Author list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hmoud Sayed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 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*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Yuk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Tsuda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Khairul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tin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,b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Ahmed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bdou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,c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Kim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artin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d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Michael F.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Burrow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e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Junji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Tagami</a:t>
            </a:r>
            <a:r>
              <a:rPr lang="en-US" sz="1800" baseline="30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a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Department of Cariology and Operative Dentistry, Graduate School of Medical and Dental Sciences, Tokyo Medical and Dental University (TMDU), Tokyo, Japan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b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ndowed Department of International Oral Health Science, Tsurumi University, Kanagawa, Japan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c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Biomaterials Department, Faculty of Oral and Dental Medicine, Modern University for Technology and Information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Mokatam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, Cairo, Egypt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d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 Department of Operative Dentistry and Periodontology, University Hospital, LMU Munich, Germany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aseline="300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e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aculty of Dentistry, University of Hong Kong, Hong Kong SAR, China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Legend: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S2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rt showing the delta E values for sound dentin treated with different tested materials at different time intervals, before and after brushing procedures. Different letter indicates significant differenc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7208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B1A4058-369A-427D-8D66-4E28688036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370668"/>
            <a:ext cx="10905066" cy="4116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1630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3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moud Macklad</dc:creator>
  <cp:lastModifiedBy>Mahmoud Macklad</cp:lastModifiedBy>
  <cp:revision>2</cp:revision>
  <dcterms:created xsi:type="dcterms:W3CDTF">2020-09-12T02:55:30Z</dcterms:created>
  <dcterms:modified xsi:type="dcterms:W3CDTF">2020-10-26T08:26:09Z</dcterms:modified>
</cp:coreProperties>
</file>